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2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ropbox\infection_R4_MHC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ropbox\infection_R4_MHCII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altLang="zh-CN" sz="1000" b="1" dirty="0"/>
              <a:t>Distribution of Peptides Length</a:t>
            </a:r>
            <a:r>
              <a:rPr lang="en-CA" altLang="zh-CN" sz="1000" b="1" baseline="0" dirty="0"/>
              <a:t> from Class I Immunopeptidome</a:t>
            </a:r>
            <a:endParaRPr lang="en-CA" altLang="zh-CN" sz="1000" b="1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924759405074365"/>
          <c:y val="0.11850977015124481"/>
          <c:w val="0.84019685039370073"/>
          <c:h val="0.733566564461440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G$6</c:f>
              <c:strCache>
                <c:ptCount val="1"/>
                <c:pt idx="0">
                  <c:v>Cou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H$5:$S$5</c:f>
              <c:strCache>
                <c:ptCount val="12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  <c:pt idx="4">
                  <c:v>11</c:v>
                </c:pt>
                <c:pt idx="5">
                  <c:v>14</c:v>
                </c:pt>
                <c:pt idx="6">
                  <c:v>15</c:v>
                </c:pt>
                <c:pt idx="7">
                  <c:v>16</c:v>
                </c:pt>
                <c:pt idx="8">
                  <c:v>17</c:v>
                </c:pt>
                <c:pt idx="9">
                  <c:v>18</c:v>
                </c:pt>
                <c:pt idx="10">
                  <c:v>19</c:v>
                </c:pt>
                <c:pt idx="11">
                  <c:v>≥20</c:v>
                </c:pt>
              </c:strCache>
            </c:strRef>
          </c:cat>
          <c:val>
            <c:numRef>
              <c:f>Sheet1!$H$6:$S$6</c:f>
              <c:numCache>
                <c:formatCode>General</c:formatCode>
                <c:ptCount val="12"/>
                <c:pt idx="0">
                  <c:v>17</c:v>
                </c:pt>
                <c:pt idx="1">
                  <c:v>56</c:v>
                </c:pt>
                <c:pt idx="2">
                  <c:v>675</c:v>
                </c:pt>
                <c:pt idx="3">
                  <c:v>244</c:v>
                </c:pt>
                <c:pt idx="4">
                  <c:v>160</c:v>
                </c:pt>
                <c:pt idx="5">
                  <c:v>14</c:v>
                </c:pt>
                <c:pt idx="6">
                  <c:v>11</c:v>
                </c:pt>
                <c:pt idx="7">
                  <c:v>9</c:v>
                </c:pt>
                <c:pt idx="8">
                  <c:v>7</c:v>
                </c:pt>
                <c:pt idx="9">
                  <c:v>9</c:v>
                </c:pt>
                <c:pt idx="10">
                  <c:v>6</c:v>
                </c:pt>
                <c:pt idx="11">
                  <c:v>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B17-4759-92BD-16A0E5F7C9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51533728"/>
        <c:axId val="253931968"/>
      </c:barChart>
      <c:catAx>
        <c:axId val="251533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53931968"/>
        <c:crosses val="autoZero"/>
        <c:auto val="1"/>
        <c:lblAlgn val="ctr"/>
        <c:lblOffset val="100"/>
        <c:noMultiLvlLbl val="0"/>
      </c:catAx>
      <c:valAx>
        <c:axId val="253931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51533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altLang="zh-CN" sz="1000" b="1" i="0" baseline="0">
                <a:effectLst/>
              </a:rPr>
              <a:t>Distribution of Peptides Length from Class I Immunopeptidome</a:t>
            </a:r>
            <a:endParaRPr lang="zh-CN" altLang="zh-CN" sz="1000" b="1">
              <a:effectLst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36920384951881"/>
          <c:y val="0.14909740449110528"/>
          <c:w val="0.8346412948381452"/>
          <c:h val="0.674058763487897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6</c:f>
              <c:strCache>
                <c:ptCount val="1"/>
                <c:pt idx="0">
                  <c:v>Cou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G$5:$Q$5</c:f>
              <c:strCache>
                <c:ptCount val="11"/>
                <c:pt idx="0">
                  <c:v>≤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  <c:pt idx="9">
                  <c:v>20</c:v>
                </c:pt>
                <c:pt idx="10">
                  <c:v>≥21</c:v>
                </c:pt>
              </c:strCache>
            </c:strRef>
          </c:cat>
          <c:val>
            <c:numRef>
              <c:f>Sheet1!$G$6:$Q$6</c:f>
              <c:numCache>
                <c:formatCode>General</c:formatCode>
                <c:ptCount val="11"/>
                <c:pt idx="0">
                  <c:v>14</c:v>
                </c:pt>
                <c:pt idx="1">
                  <c:v>18</c:v>
                </c:pt>
                <c:pt idx="2">
                  <c:v>68</c:v>
                </c:pt>
                <c:pt idx="3">
                  <c:v>190</c:v>
                </c:pt>
                <c:pt idx="4">
                  <c:v>335</c:v>
                </c:pt>
                <c:pt idx="5">
                  <c:v>305</c:v>
                </c:pt>
                <c:pt idx="6">
                  <c:v>200</c:v>
                </c:pt>
                <c:pt idx="7">
                  <c:v>104</c:v>
                </c:pt>
                <c:pt idx="8">
                  <c:v>61</c:v>
                </c:pt>
                <c:pt idx="9">
                  <c:v>43</c:v>
                </c:pt>
                <c:pt idx="10">
                  <c:v>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21A-414C-A244-25499706F9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4123016"/>
        <c:axId val="124123408"/>
      </c:barChart>
      <c:catAx>
        <c:axId val="124123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23408"/>
        <c:crosses val="autoZero"/>
        <c:auto val="1"/>
        <c:lblAlgn val="ctr"/>
        <c:lblOffset val="100"/>
        <c:noMultiLvlLbl val="0"/>
      </c:catAx>
      <c:valAx>
        <c:axId val="124123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23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bserved gene cou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11</c:f>
              <c:strCache>
                <c:ptCount val="10"/>
                <c:pt idx="0">
                  <c:v>Intrinsic component of membrane</c:v>
                </c:pt>
                <c:pt idx="1">
                  <c:v>Integral component of membrane</c:v>
                </c:pt>
                <c:pt idx="2">
                  <c:v>Membrane</c:v>
                </c:pt>
                <c:pt idx="3">
                  <c:v>Endomembrane system</c:v>
                </c:pt>
                <c:pt idx="4">
                  <c:v>Extracellular region</c:v>
                </c:pt>
                <c:pt idx="5">
                  <c:v>Extracellular space</c:v>
                </c:pt>
                <c:pt idx="6">
                  <c:v>Extracellular vesicle</c:v>
                </c:pt>
                <c:pt idx="7">
                  <c:v>Extracellular exosome</c:v>
                </c:pt>
                <c:pt idx="8">
                  <c:v>Vesicle</c:v>
                </c:pt>
                <c:pt idx="9">
                  <c:v>Cell surface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585</c:v>
                </c:pt>
                <c:pt idx="1">
                  <c:v>564</c:v>
                </c:pt>
                <c:pt idx="2">
                  <c:v>699</c:v>
                </c:pt>
                <c:pt idx="3">
                  <c:v>490</c:v>
                </c:pt>
                <c:pt idx="4">
                  <c:v>458</c:v>
                </c:pt>
                <c:pt idx="5">
                  <c:v>385</c:v>
                </c:pt>
                <c:pt idx="6">
                  <c:v>308</c:v>
                </c:pt>
                <c:pt idx="7">
                  <c:v>305</c:v>
                </c:pt>
                <c:pt idx="8">
                  <c:v>412</c:v>
                </c:pt>
                <c:pt idx="9">
                  <c:v>1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FEE-4E9D-A52C-29090F4070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124192"/>
        <c:axId val="124124584"/>
      </c:barChar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false discovery r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heet1!$A$2:$A$11</c:f>
              <c:strCache>
                <c:ptCount val="10"/>
                <c:pt idx="0">
                  <c:v>Intrinsic component of membrane</c:v>
                </c:pt>
                <c:pt idx="1">
                  <c:v>Integral component of membrane</c:v>
                </c:pt>
                <c:pt idx="2">
                  <c:v>Membrane</c:v>
                </c:pt>
                <c:pt idx="3">
                  <c:v>Endomembrane system</c:v>
                </c:pt>
                <c:pt idx="4">
                  <c:v>Extracellular region</c:v>
                </c:pt>
                <c:pt idx="5">
                  <c:v>Extracellular space</c:v>
                </c:pt>
                <c:pt idx="6">
                  <c:v>Extracellular vesicle</c:v>
                </c:pt>
                <c:pt idx="7">
                  <c:v>Extracellular exosome</c:v>
                </c:pt>
                <c:pt idx="8">
                  <c:v>Vesicle</c:v>
                </c:pt>
                <c:pt idx="9">
                  <c:v>Cell surface</c:v>
                </c:pt>
              </c:strCache>
            </c:strRef>
          </c:cat>
          <c:val>
            <c:numRef>
              <c:f>Sheet1!$C$2:$C$11</c:f>
              <c:numCache>
                <c:formatCode>0.00E+00</c:formatCode>
                <c:ptCount val="10"/>
                <c:pt idx="0">
                  <c:v>3.61E-129</c:v>
                </c:pt>
                <c:pt idx="1">
                  <c:v>1.81E-120</c:v>
                </c:pt>
                <c:pt idx="2">
                  <c:v>3.26E-96</c:v>
                </c:pt>
                <c:pt idx="3">
                  <c:v>1.2799999999999999E-94</c:v>
                </c:pt>
                <c:pt idx="4">
                  <c:v>4.06E-88</c:v>
                </c:pt>
                <c:pt idx="5">
                  <c:v>1.6700000000000001E-79</c:v>
                </c:pt>
                <c:pt idx="6">
                  <c:v>5.5800000000000002E-77</c:v>
                </c:pt>
                <c:pt idx="7">
                  <c:v>3.1899999999999997E-76</c:v>
                </c:pt>
                <c:pt idx="8">
                  <c:v>1.58E-71</c:v>
                </c:pt>
                <c:pt idx="9">
                  <c:v>2.0499999999999999E-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FEE-4E9D-A52C-29090F4070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4125368"/>
        <c:axId val="124124976"/>
      </c:lineChart>
      <c:catAx>
        <c:axId val="124124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24584"/>
        <c:crosses val="autoZero"/>
        <c:auto val="1"/>
        <c:lblAlgn val="ctr"/>
        <c:lblOffset val="100"/>
        <c:noMultiLvlLbl val="0"/>
      </c:catAx>
      <c:valAx>
        <c:axId val="124124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24192"/>
        <c:crosses val="autoZero"/>
        <c:crossBetween val="between"/>
      </c:valAx>
      <c:valAx>
        <c:axId val="124124976"/>
        <c:scaling>
          <c:orientation val="minMax"/>
        </c:scaling>
        <c:delete val="0"/>
        <c:axPos val="r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25368"/>
        <c:crosses val="max"/>
        <c:crossBetween val="between"/>
      </c:valAx>
      <c:catAx>
        <c:axId val="1241253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41249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b="1"/>
              <a:t>TLR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8!$B$1</c:f>
              <c:strCache>
                <c:ptCount val="1"/>
                <c:pt idx="0">
                  <c:v>Control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B$2:$B$9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12248000</c:v>
                </c:pt>
                <c:pt idx="3">
                  <c:v>11839000</c:v>
                </c:pt>
                <c:pt idx="4">
                  <c:v>5678800</c:v>
                </c:pt>
                <c:pt idx="5">
                  <c:v>15624000</c:v>
                </c:pt>
                <c:pt idx="6">
                  <c:v>15624000</c:v>
                </c:pt>
                <c:pt idx="7">
                  <c:v>22070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C6B-4203-B51B-FF7AF9B086F3}"/>
            </c:ext>
          </c:extLst>
        </c:ser>
        <c:ser>
          <c:idx val="1"/>
          <c:order val="1"/>
          <c:tx>
            <c:strRef>
              <c:f>Sheet8!$C$1</c:f>
              <c:strCache>
                <c:ptCount val="1"/>
                <c:pt idx="0">
                  <c:v>Contro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C$2:$C$9</c:f>
              <c:numCache>
                <c:formatCode>General</c:formatCode>
                <c:ptCount val="8"/>
                <c:pt idx="0">
                  <c:v>51201000</c:v>
                </c:pt>
                <c:pt idx="1">
                  <c:v>51201000</c:v>
                </c:pt>
                <c:pt idx="2">
                  <c:v>28444000</c:v>
                </c:pt>
                <c:pt idx="3">
                  <c:v>0</c:v>
                </c:pt>
                <c:pt idx="4">
                  <c:v>1538700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C6B-4203-B51B-FF7AF9B086F3}"/>
            </c:ext>
          </c:extLst>
        </c:ser>
        <c:ser>
          <c:idx val="2"/>
          <c:order val="2"/>
          <c:tx>
            <c:strRef>
              <c:f>Sheet8!$D$1</c:f>
              <c:strCache>
                <c:ptCount val="1"/>
                <c:pt idx="0">
                  <c:v>Control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D$2:$D$9</c:f>
              <c:numCache>
                <c:formatCode>General</c:formatCode>
                <c:ptCount val="8"/>
                <c:pt idx="0">
                  <c:v>39290000</c:v>
                </c:pt>
                <c:pt idx="1">
                  <c:v>39290000</c:v>
                </c:pt>
                <c:pt idx="2">
                  <c:v>0</c:v>
                </c:pt>
                <c:pt idx="3">
                  <c:v>20820000</c:v>
                </c:pt>
                <c:pt idx="4">
                  <c:v>7058500</c:v>
                </c:pt>
                <c:pt idx="5">
                  <c:v>0</c:v>
                </c:pt>
                <c:pt idx="6">
                  <c:v>0</c:v>
                </c:pt>
                <c:pt idx="7">
                  <c:v>30025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C6B-4203-B51B-FF7AF9B086F3}"/>
            </c:ext>
          </c:extLst>
        </c:ser>
        <c:ser>
          <c:idx val="3"/>
          <c:order val="3"/>
          <c:tx>
            <c:strRef>
              <c:f>Sheet8!$E$1</c:f>
              <c:strCache>
                <c:ptCount val="1"/>
                <c:pt idx="0">
                  <c:v>Infection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E$2:$E$9</c:f>
              <c:numCache>
                <c:formatCode>General</c:formatCode>
                <c:ptCount val="8"/>
                <c:pt idx="0">
                  <c:v>24508000</c:v>
                </c:pt>
                <c:pt idx="1">
                  <c:v>0</c:v>
                </c:pt>
                <c:pt idx="2">
                  <c:v>92080000</c:v>
                </c:pt>
                <c:pt idx="3">
                  <c:v>30107000</c:v>
                </c:pt>
                <c:pt idx="4">
                  <c:v>33807000</c:v>
                </c:pt>
                <c:pt idx="5">
                  <c:v>31145000</c:v>
                </c:pt>
                <c:pt idx="6">
                  <c:v>31145000</c:v>
                </c:pt>
                <c:pt idx="7">
                  <c:v>52758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6C6B-4203-B51B-FF7AF9B086F3}"/>
            </c:ext>
          </c:extLst>
        </c:ser>
        <c:ser>
          <c:idx val="4"/>
          <c:order val="4"/>
          <c:tx>
            <c:strRef>
              <c:f>Sheet8!$F$1</c:f>
              <c:strCache>
                <c:ptCount val="1"/>
                <c:pt idx="0">
                  <c:v>Infection2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F$2:$F$9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58225000</c:v>
                </c:pt>
                <c:pt idx="3">
                  <c:v>18933000</c:v>
                </c:pt>
                <c:pt idx="4">
                  <c:v>18978000</c:v>
                </c:pt>
                <c:pt idx="5">
                  <c:v>27148000</c:v>
                </c:pt>
                <c:pt idx="6">
                  <c:v>27148000</c:v>
                </c:pt>
                <c:pt idx="7">
                  <c:v>36113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6C6B-4203-B51B-FF7AF9B086F3}"/>
            </c:ext>
          </c:extLst>
        </c:ser>
        <c:ser>
          <c:idx val="5"/>
          <c:order val="5"/>
          <c:tx>
            <c:strRef>
              <c:f>Sheet8!$G$1</c:f>
              <c:strCache>
                <c:ptCount val="1"/>
                <c:pt idx="0">
                  <c:v>Infection3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8!$A$2:$A$9</c:f>
              <c:strCache>
                <c:ptCount val="8"/>
                <c:pt idx="0">
                  <c:v>N52</c:v>
                </c:pt>
                <c:pt idx="1">
                  <c:v>N57</c:v>
                </c:pt>
                <c:pt idx="2">
                  <c:v>N124</c:v>
                </c:pt>
                <c:pt idx="3">
                  <c:v>N196</c:v>
                </c:pt>
                <c:pt idx="4">
                  <c:v>N247</c:v>
                </c:pt>
                <c:pt idx="5">
                  <c:v>N398</c:v>
                </c:pt>
                <c:pt idx="6">
                  <c:v>N413</c:v>
                </c:pt>
                <c:pt idx="7">
                  <c:v>N507</c:v>
                </c:pt>
              </c:strCache>
            </c:strRef>
          </c:cat>
          <c:val>
            <c:numRef>
              <c:f>Sheet8!$G$2:$G$9</c:f>
              <c:numCache>
                <c:formatCode>General</c:formatCode>
                <c:ptCount val="8"/>
                <c:pt idx="0">
                  <c:v>142650000</c:v>
                </c:pt>
                <c:pt idx="1">
                  <c:v>112160000</c:v>
                </c:pt>
                <c:pt idx="2">
                  <c:v>99939000</c:v>
                </c:pt>
                <c:pt idx="3">
                  <c:v>27086000</c:v>
                </c:pt>
                <c:pt idx="4">
                  <c:v>27752000</c:v>
                </c:pt>
                <c:pt idx="5">
                  <c:v>0</c:v>
                </c:pt>
                <c:pt idx="6">
                  <c:v>0</c:v>
                </c:pt>
                <c:pt idx="7">
                  <c:v>77258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6C6B-4203-B51B-FF7AF9B086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4126152"/>
        <c:axId val="124126544"/>
      </c:barChart>
      <c:catAx>
        <c:axId val="124126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26544"/>
        <c:crosses val="autoZero"/>
        <c:auto val="1"/>
        <c:lblAlgn val="ctr"/>
        <c:lblOffset val="100"/>
        <c:noMultiLvlLbl val="0"/>
      </c:catAx>
      <c:valAx>
        <c:axId val="124126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261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066</cdr:x>
      <cdr:y>0.40108</cdr:y>
    </cdr:from>
    <cdr:to>
      <cdr:x>0.05858</cdr:x>
      <cdr:y>0.64414</cdr:y>
    </cdr:to>
    <cdr:sp macro="" textlink="">
      <cdr:nvSpPr>
        <cdr:cNvPr id="3" name="TextBox 7">
          <a:extLst xmlns:a="http://schemas.openxmlformats.org/drawingml/2006/main">
            <a:ext uri="{FF2B5EF4-FFF2-40B4-BE49-F238E27FC236}">
              <a16:creationId xmlns="" xmlns:a16="http://schemas.microsoft.com/office/drawing/2014/main" id="{17C70A3C-5EC3-43DE-BB4E-7849AFB5DE05}"/>
            </a:ext>
          </a:extLst>
        </cdr:cNvPr>
        <cdr:cNvSpPr txBox="1"/>
      </cdr:nvSpPr>
      <cdr:spPr>
        <a:xfrm xmlns:a="http://schemas.openxmlformats.org/drawingml/2006/main" rot="5400000">
          <a:off x="-276476" y="1861712"/>
          <a:ext cx="925895" cy="258127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defPPr>
            <a:defRPr lang="zh-CN"/>
          </a:defPPr>
          <a:lvl1pPr marL="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altLang="zh-CN" sz="1100" dirty="0"/>
            <a:t>count</a:t>
          </a:r>
          <a:endParaRPr lang="zh-CN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9692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3794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5301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1794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55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8465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28223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3013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5595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1916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5086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27411-D03A-486A-AECC-C2E523918FFB}" type="datetimeFigureOut">
              <a:rPr lang="en-CA" smtClean="0"/>
              <a:t>26/05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D4C2E-8C10-45B3-A549-12E73B421A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8638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0EACED39-A0DB-4797-8838-5EED0597DE6E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1  </a:t>
            </a:r>
            <a:r>
              <a:rPr lang="en-CA" altLang="zh-CN" dirty="0"/>
              <a:t>Distribution Peptides Length from Calu-3 Immunopeptidome</a:t>
            </a:r>
            <a:endParaRPr lang="zh-CN" altLang="en-US" dirty="0"/>
          </a:p>
        </p:txBody>
      </p:sp>
      <p:graphicFrame>
        <p:nvGraphicFramePr>
          <p:cNvPr id="5" name="Chart 4">
            <a:extLst>
              <a:ext uri="{FF2B5EF4-FFF2-40B4-BE49-F238E27FC236}">
                <a16:creationId xmlns="" xmlns:a16="http://schemas.microsoft.com/office/drawing/2014/main" id="{18E29FAA-73DA-451A-B734-43407EE854A8}"/>
              </a:ext>
            </a:extLst>
          </p:cNvPr>
          <p:cNvGraphicFramePr>
            <a:graphicFrameLocks/>
          </p:cNvGraphicFramePr>
          <p:nvPr/>
        </p:nvGraphicFramePr>
        <p:xfrm>
          <a:off x="158975" y="1412455"/>
          <a:ext cx="5314265" cy="3921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3">
            <a:extLst>
              <a:ext uri="{FF2B5EF4-FFF2-40B4-BE49-F238E27FC236}">
                <a16:creationId xmlns="" xmlns:a16="http://schemas.microsoft.com/office/drawing/2014/main" id="{C0A81E20-142C-4556-A68B-ECBB25420E83}"/>
              </a:ext>
            </a:extLst>
          </p:cNvPr>
          <p:cNvSpPr txBox="1"/>
          <p:nvPr/>
        </p:nvSpPr>
        <p:spPr>
          <a:xfrm>
            <a:off x="1692157" y="5042683"/>
            <a:ext cx="2247900" cy="228600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altLang="zh-CN" sz="1100" dirty="0"/>
              <a:t>Number of Amino Acid</a:t>
            </a:r>
            <a:endParaRPr lang="zh-CN" altLang="en-US" sz="1100" dirty="0"/>
          </a:p>
        </p:txBody>
      </p:sp>
      <p:sp>
        <p:nvSpPr>
          <p:cNvPr id="7" name="TextBox 7">
            <a:extLst>
              <a:ext uri="{FF2B5EF4-FFF2-40B4-BE49-F238E27FC236}">
                <a16:creationId xmlns="" xmlns:a16="http://schemas.microsoft.com/office/drawing/2014/main" id="{964155BB-6CB0-483A-848A-223578EBFF1D}"/>
              </a:ext>
            </a:extLst>
          </p:cNvPr>
          <p:cNvSpPr txBox="1"/>
          <p:nvPr/>
        </p:nvSpPr>
        <p:spPr>
          <a:xfrm rot="5400000">
            <a:off x="-1362" y="3131103"/>
            <a:ext cx="666750" cy="219075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altLang="zh-CN" sz="1100" dirty="0"/>
              <a:t>count</a:t>
            </a:r>
            <a:endParaRPr lang="zh-CN" altLang="en-US" sz="1100" dirty="0"/>
          </a:p>
        </p:txBody>
      </p:sp>
      <p:graphicFrame>
        <p:nvGraphicFramePr>
          <p:cNvPr id="8" name="Chart 7">
            <a:extLst>
              <a:ext uri="{FF2B5EF4-FFF2-40B4-BE49-F238E27FC236}">
                <a16:creationId xmlns="" xmlns:a16="http://schemas.microsoft.com/office/drawing/2014/main" id="{FA69CC09-DB36-492D-9035-27A9488E244F}"/>
              </a:ext>
            </a:extLst>
          </p:cNvPr>
          <p:cNvGraphicFramePr>
            <a:graphicFrameLocks/>
          </p:cNvGraphicFramePr>
          <p:nvPr/>
        </p:nvGraphicFramePr>
        <p:xfrm>
          <a:off x="6324055" y="1669352"/>
          <a:ext cx="5386628" cy="3809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3">
            <a:extLst>
              <a:ext uri="{FF2B5EF4-FFF2-40B4-BE49-F238E27FC236}">
                <a16:creationId xmlns="" xmlns:a16="http://schemas.microsoft.com/office/drawing/2014/main" id="{0A704498-B59F-40A3-A1B4-D6A1040AA48D}"/>
              </a:ext>
            </a:extLst>
          </p:cNvPr>
          <p:cNvSpPr txBox="1"/>
          <p:nvPr/>
        </p:nvSpPr>
        <p:spPr>
          <a:xfrm>
            <a:off x="8138005" y="5110711"/>
            <a:ext cx="2480237" cy="265906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altLang="zh-CN" sz="1100" dirty="0"/>
              <a:t>Number of Amino Acid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36007917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C0BEBF15-134F-4348-B208-B5B73D10A4B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908" y="1835378"/>
            <a:ext cx="5033282" cy="379245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832C35DE-2F4C-4A4D-A972-52C7173B8702}"/>
              </a:ext>
            </a:extLst>
          </p:cNvPr>
          <p:cNvSpPr txBox="1"/>
          <p:nvPr/>
        </p:nvSpPr>
        <p:spPr>
          <a:xfrm>
            <a:off x="0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2  </a:t>
            </a:r>
            <a:r>
              <a:rPr lang="en-CA" altLang="zh-CN" dirty="0"/>
              <a:t>Overlap of Calu-3 Immunopeptidome from Control and Infected Cell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7C67C5E0-8C64-439D-8D00-BE7097617A30}"/>
              </a:ext>
            </a:extLst>
          </p:cNvPr>
          <p:cNvSpPr txBox="1"/>
          <p:nvPr/>
        </p:nvSpPr>
        <p:spPr>
          <a:xfrm>
            <a:off x="302607" y="1045968"/>
            <a:ext cx="2282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zh-CN" b="1" dirty="0"/>
              <a:t>MHC I</a:t>
            </a:r>
            <a:endParaRPr lang="zh-CN" altLang="en-US" b="1" dirty="0"/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DA0FB270-B280-438C-8B5B-158EB3B20592}"/>
              </a:ext>
            </a:extLst>
          </p:cNvPr>
          <p:cNvSpPr txBox="1"/>
          <p:nvPr/>
        </p:nvSpPr>
        <p:spPr>
          <a:xfrm>
            <a:off x="6224279" y="1137126"/>
            <a:ext cx="2282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zh-CN" b="1" dirty="0"/>
              <a:t>MHC II</a:t>
            </a:r>
            <a:endParaRPr lang="zh-CN" altLang="en-US" b="1" dirty="0"/>
          </a:p>
        </p:txBody>
      </p: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A04015CE-C0E5-4AF8-BC02-4973CA60A35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743" y="2027093"/>
            <a:ext cx="4902320" cy="3693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69340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DCD96EDC-C2C2-4261-8AD2-2F548D71311A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3  MS/MS Spectra of identified </a:t>
            </a:r>
            <a:r>
              <a:rPr lang="en-CA" altLang="zh-CN" dirty="0"/>
              <a:t>epitopes from SARS-Cov-2 presented by MHC </a:t>
            </a:r>
            <a:endParaRPr lang="zh-CN" alt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3AB9BECA-51C9-40E6-9C55-BCC2307D89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9867" y="989435"/>
            <a:ext cx="3511276" cy="225051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26F5DCB1-9AC4-4666-9D00-9F35AE3B00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921181"/>
            <a:ext cx="3423266" cy="219788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="" xmlns:a16="http://schemas.microsoft.com/office/drawing/2014/main" id="{A5D8C7A7-78CF-3A30-F91C-06FF2915AD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3719" y="3670917"/>
            <a:ext cx="3898740" cy="291430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="" xmlns:a16="http://schemas.microsoft.com/office/drawing/2014/main" id="{D40C3C45-E651-8EE8-BB34-13C949550C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33616" y="3594907"/>
            <a:ext cx="4639224" cy="312367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="" xmlns:a16="http://schemas.microsoft.com/office/drawing/2014/main" id="{A413DF87-08F6-2055-C87E-441296F5CA0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27745" y="707638"/>
            <a:ext cx="3830533" cy="26677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05854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DCD96EDC-C2C2-4261-8AD2-2F548D71311A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4  </a:t>
            </a:r>
            <a:r>
              <a:rPr lang="en-CA" altLang="zh-CN" dirty="0"/>
              <a:t>Correlation of Label-free quantification intensity of proteins from replicates</a:t>
            </a:r>
            <a:endParaRPr lang="zh-CN" altLang="en-US" dirty="0"/>
          </a:p>
        </p:txBody>
      </p:sp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45A42B5E-26BA-4539-BC24-9FE7E46E8DD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92497" y="951213"/>
          <a:ext cx="5025884" cy="36997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4222951" imgH="2255695" progId="Prism9.Document">
                  <p:embed/>
                </p:oleObj>
              </mc:Choice>
              <mc:Fallback>
                <p:oleObj name="Prism 9" r:id="rId3" imgW="4222951" imgH="225569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2497" y="951213"/>
                        <a:ext cx="5025884" cy="36997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6E89B46D-D5CF-4F27-A75F-45DC50057D1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909187" y="951213"/>
          <a:ext cx="5318382" cy="3484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5" imgW="4111669" imgH="2712955" progId="Prism9.Document">
                  <p:embed/>
                </p:oleObj>
              </mc:Choice>
              <mc:Fallback>
                <p:oleObj name="Prism 9" r:id="rId5" imgW="4111669" imgH="27129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09187" y="951213"/>
                        <a:ext cx="5318382" cy="3484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133599" y="930361"/>
            <a:ext cx="2743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R</a:t>
            </a:r>
            <a:r>
              <a:rPr lang="en-CA" baseline="30000" dirty="0"/>
              <a:t>2</a:t>
            </a:r>
            <a:r>
              <a:rPr lang="en-CA" dirty="0"/>
              <a:t> =0.9846,P&lt;0.0001</a:t>
            </a:r>
            <a:endParaRPr lang="en-CA" baseline="30000" dirty="0"/>
          </a:p>
        </p:txBody>
      </p:sp>
      <p:sp>
        <p:nvSpPr>
          <p:cNvPr id="6" name="TextBox 5"/>
          <p:cNvSpPr txBox="1"/>
          <p:nvPr/>
        </p:nvSpPr>
        <p:spPr>
          <a:xfrm>
            <a:off x="8068962" y="951213"/>
            <a:ext cx="2743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R</a:t>
            </a:r>
            <a:r>
              <a:rPr lang="en-CA" baseline="30000" dirty="0"/>
              <a:t>2</a:t>
            </a:r>
            <a:r>
              <a:rPr lang="en-CA" dirty="0"/>
              <a:t> =0.9830, P&lt;0.0001</a:t>
            </a:r>
            <a:endParaRPr lang="en-CA" baseline="30000" dirty="0"/>
          </a:p>
        </p:txBody>
      </p:sp>
    </p:spTree>
    <p:extLst>
      <p:ext uri="{BB962C8B-B14F-4D97-AF65-F5344CB8AC3E}">
        <p14:creationId xmlns:p14="http://schemas.microsoft.com/office/powerpoint/2010/main" val="9393448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F19F25AE-E6BF-47BD-B53E-82B74EF2FA75}"/>
              </a:ext>
            </a:extLst>
          </p:cNvPr>
          <p:cNvGraphicFramePr>
            <a:graphicFrameLocks noGrp="1"/>
          </p:cNvGraphicFramePr>
          <p:nvPr>
            <p:ph idx="1"/>
            <p:extLst/>
          </p:nvPr>
        </p:nvGraphicFramePr>
        <p:xfrm>
          <a:off x="627690" y="1253331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D22B7F58-35B3-4B20-951E-61163B2AF946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5  </a:t>
            </a:r>
            <a:r>
              <a:rPr lang="en-CA" altLang="zh-CN" dirty="0"/>
              <a:t>Enrichment of membrane proteins identified by </a:t>
            </a:r>
            <a:r>
              <a:rPr lang="en-CA" altLang="zh-CN" dirty="0" err="1"/>
              <a:t>glycoproteomic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091633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4FDFB3A3-EEEF-4D1E-A285-55169ED50B22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6  </a:t>
            </a:r>
            <a:r>
              <a:rPr lang="en-CA" altLang="zh-CN" dirty="0"/>
              <a:t>Abundance of all N-</a:t>
            </a:r>
            <a:r>
              <a:rPr lang="en-CA" altLang="zh-CN" dirty="0" err="1"/>
              <a:t>glycosites</a:t>
            </a:r>
            <a:r>
              <a:rPr lang="en-CA" altLang="zh-CN" dirty="0"/>
              <a:t> of TLR3 </a:t>
            </a:r>
            <a:endParaRPr lang="zh-CN" altLang="en-US" dirty="0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607671" y="949124"/>
          <a:ext cx="8246962" cy="5150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898223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DB306821-E34F-4EA3-9D86-3EAC47817F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3746"/>
            <a:ext cx="5927154" cy="364485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17123FD2-C091-4906-8256-D39806AC14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27153" y="1605928"/>
            <a:ext cx="6103121" cy="354832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8826" y="255639"/>
            <a:ext cx="11434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7  MS/MS of Degraded HLA </a:t>
            </a:r>
            <a:r>
              <a:rPr lang="en-US" dirty="0" err="1"/>
              <a:t>Glycopeptides</a:t>
            </a:r>
            <a:r>
              <a:rPr lang="en-US" dirty="0"/>
              <a:t> from Infected Cell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8832343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C2A28139-CC48-455B-8855-9B19B9FFBB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2406" y="713748"/>
            <a:ext cx="4654225" cy="584923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5792CA79-3A89-45FA-AC57-48182503EAE0}"/>
              </a:ext>
            </a:extLst>
          </p:cNvPr>
          <p:cNvSpPr txBox="1"/>
          <p:nvPr/>
        </p:nvSpPr>
        <p:spPr>
          <a:xfrm>
            <a:off x="-1" y="0"/>
            <a:ext cx="1155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8  </a:t>
            </a:r>
            <a:r>
              <a:rPr lang="en-CA" altLang="zh-CN" dirty="0"/>
              <a:t>ErBB2 was identified in the protein fraction of MHC immunoprecipitatio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458467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20</Words>
  <Application>Microsoft Office PowerPoint</Application>
  <PresentationFormat>Widescreen</PresentationFormat>
  <Paragraphs>19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RC-CN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Rui</dc:creator>
  <cp:lastModifiedBy>Chen, Rui</cp:lastModifiedBy>
  <cp:revision>2</cp:revision>
  <dcterms:created xsi:type="dcterms:W3CDTF">2022-05-26T13:20:17Z</dcterms:created>
  <dcterms:modified xsi:type="dcterms:W3CDTF">2022-05-26T13:33:25Z</dcterms:modified>
</cp:coreProperties>
</file>